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6" r:id="rId2"/>
  </p:sldIdLst>
  <p:sldSz cx="6858000" cy="9906000" type="A4"/>
  <p:notesSz cx="6797675" cy="9926638"/>
  <p:defaultTextStyle>
    <a:defPPr>
      <a:defRPr lang="en-GB"/>
    </a:defPPr>
    <a:lvl1pPr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5pPr>
    <a:lvl6pPr marL="22860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6pPr>
    <a:lvl7pPr marL="27432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7pPr>
    <a:lvl8pPr marL="32004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8pPr>
    <a:lvl9pPr marL="36576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8FEEC"/>
    <a:srgbClr val="663300"/>
    <a:srgbClr val="996633"/>
    <a:srgbClr val="F8C1B6"/>
    <a:srgbClr val="2FFFCD"/>
    <a:srgbClr val="FF47FF"/>
    <a:srgbClr val="F03218"/>
    <a:srgbClr val="FFCC00"/>
    <a:srgbClr val="096D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snapVertSplitter="1" vertBarState="minimized" horzBarState="maximized">
    <p:restoredLeft sz="3820" autoAdjust="0"/>
    <p:restoredTop sz="86407" autoAdjust="0"/>
  </p:normalViewPr>
  <p:slideViewPr>
    <p:cSldViewPr snapToGrid="0">
      <p:cViewPr varScale="1">
        <p:scale>
          <a:sx n="99" d="100"/>
          <a:sy n="99" d="100"/>
        </p:scale>
        <p:origin x="1956" y="102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13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640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099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51275" y="0"/>
            <a:ext cx="294640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100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429750"/>
            <a:ext cx="294640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101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51275" y="9429750"/>
            <a:ext cx="294640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665EB616-CABF-4B7C-8565-3F13A2DBAE37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370985491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Times New Roman" charset="0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Times New Roman" charset="0"/>
              </a:defRPr>
            </a:lvl1pPr>
          </a:lstStyle>
          <a:p>
            <a:pPr>
              <a:defRPr/>
            </a:pPr>
            <a:fld id="{3B58F2DE-17C5-4142-9F39-686B0848F31E}" type="datetimeFigureOut">
              <a:rPr lang="en-US"/>
              <a:pPr>
                <a:defRPr/>
              </a:pPr>
              <a:t>5/5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09788" y="744538"/>
            <a:ext cx="25781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GB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14875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GB" noProof="0" smtClean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Times New Roman" charset="0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latin typeface="Times New Roman" charset="0"/>
              </a:defRPr>
            </a:lvl1pPr>
          </a:lstStyle>
          <a:p>
            <a:pPr>
              <a:defRPr/>
            </a:pPr>
            <a:fld id="{04DFB875-2F53-4D6C-ADAB-812F19EB2EED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8417546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6579"/>
            <a:ext cx="5829300" cy="212407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3"/>
            <a:ext cx="4800600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C7B3581-3040-4C47-ADF3-F7D4BDF131EF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9970985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6717908-283F-4A2E-8FCF-7BC83614E92F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28356670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886331" y="881063"/>
            <a:ext cx="1457325" cy="79248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4355" y="881063"/>
            <a:ext cx="4219575" cy="79248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6B84506-8937-496E-A9A5-506A604EF8FB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5929845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EF88204-B65D-423C-82DF-4A8B8B464684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2529368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6365878"/>
            <a:ext cx="5829300" cy="19669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4198938"/>
            <a:ext cx="5829300" cy="2166938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98640E2-38E6-4B95-8168-088FE1B739E8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26159394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4350" y="2862263"/>
            <a:ext cx="2838450" cy="59436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862263"/>
            <a:ext cx="2838450" cy="59436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CDE9D79-45D0-4CF4-9705-888B56937B27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16732681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875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738"/>
            <a:ext cx="3030538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666"/>
            <a:ext cx="3030538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9" y="2217738"/>
            <a:ext cx="3030537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9" y="3141666"/>
            <a:ext cx="3030537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1736B4A-D98C-4FDE-82E5-666406FC6D72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13340670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4D88AC4-24D4-4E5E-9378-7ED6E2E80DB9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233304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D83B130-67A1-42C9-9B68-17CCECACC0B3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37661579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3703"/>
            <a:ext cx="2255838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3700"/>
            <a:ext cx="3833812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3274"/>
            <a:ext cx="2255838" cy="67754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2EAF75-1BEF-4565-B096-D8E8C0F6EE3B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23185445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934200"/>
            <a:ext cx="4114800" cy="819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85825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753349"/>
            <a:ext cx="4114800" cy="11620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E3C5CCA-D13F-480E-AAE9-F766CFFA9F86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  <p:extLst>
      <p:ext uri="{BB962C8B-B14F-4D97-AF65-F5344CB8AC3E}">
        <p14:creationId xmlns:p14="http://schemas.microsoft.com/office/powerpoint/2010/main" val="12047887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514350" y="881063"/>
            <a:ext cx="5829300" cy="165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GB" altLang="zh-CN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514350" y="2862263"/>
            <a:ext cx="5829300" cy="5943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altLang="zh-CN" smtClean="0"/>
              <a:t>Click to edit Master text styles</a:t>
            </a:r>
          </a:p>
          <a:p>
            <a:pPr lvl="1"/>
            <a:r>
              <a:rPr lang="en-GB" altLang="zh-CN" smtClean="0"/>
              <a:t>Second level</a:t>
            </a:r>
          </a:p>
          <a:p>
            <a:pPr lvl="2"/>
            <a:r>
              <a:rPr lang="en-GB" altLang="zh-CN" smtClean="0"/>
              <a:t>Third level</a:t>
            </a:r>
          </a:p>
          <a:p>
            <a:pPr lvl="3"/>
            <a:r>
              <a:rPr lang="en-GB" altLang="zh-CN" smtClean="0"/>
              <a:t>Fourth level</a:t>
            </a:r>
          </a:p>
          <a:p>
            <a:pPr lvl="4"/>
            <a:r>
              <a:rPr lang="en-GB" altLang="zh-CN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514350" y="9024938"/>
            <a:ext cx="1428750" cy="66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9024938"/>
            <a:ext cx="2171700" cy="66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ea typeface="宋体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9024938"/>
            <a:ext cx="1428750" cy="66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ea typeface="宋体" pitchFamily="2" charset="-122"/>
              </a:defRPr>
            </a:lvl1pPr>
          </a:lstStyle>
          <a:p>
            <a:pPr>
              <a:defRPr/>
            </a:pPr>
            <a:fld id="{CFB04EDC-854A-47E1-A7BC-53B84277158A}" type="slidenum">
              <a:rPr lang="zh-CN" altLang="en-GB"/>
              <a:pPr>
                <a:defRPr/>
              </a:pPr>
              <a:t>‹#›</a:t>
            </a:fld>
            <a:endParaRPr lang="en-GB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94208" y="6792939"/>
            <a:ext cx="6333067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100" b="1" dirty="0">
                <a:latin typeface="Calibri" panose="020F0502020204030204" pitchFamily="34" charset="0"/>
                <a:cs typeface="Calibri" panose="020F0502020204030204" pitchFamily="34" charset="0"/>
              </a:rPr>
              <a:t>Supplementary Figure </a:t>
            </a:r>
            <a:r>
              <a:rPr lang="en-GB" sz="11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S4. </a:t>
            </a:r>
            <a:r>
              <a:rPr lang="en-GB" sz="1100" dirty="0">
                <a:latin typeface="Calibri" panose="020F0502020204030204" pitchFamily="34" charset="0"/>
                <a:cs typeface="Calibri" panose="020F0502020204030204" pitchFamily="34" charset="0"/>
              </a:rPr>
              <a:t>Mutation profile in various lymphoma entities investigated by 93 gene panel sequencing. Other comprises MALT lymphoma of the lung (n=2) and soft tissue (n=1).  TH_MALT:  thyroid MALT lymphoma</a:t>
            </a:r>
            <a:r>
              <a:rPr lang="en-GB" sz="1100">
                <a:latin typeface="Calibri" panose="020F0502020204030204" pitchFamily="34" charset="0"/>
                <a:cs typeface="Calibri" panose="020F0502020204030204" pitchFamily="34" charset="0"/>
              </a:rPr>
              <a:t>; </a:t>
            </a:r>
            <a:r>
              <a:rPr lang="en-GB" sz="1100" smtClean="0">
                <a:latin typeface="Calibri" panose="020F0502020204030204" pitchFamily="34" charset="0"/>
                <a:cs typeface="Calibri" panose="020F0502020204030204" pitchFamily="34" charset="0"/>
              </a:rPr>
              <a:t>OA_MALT</a:t>
            </a:r>
            <a:r>
              <a:rPr lang="en-GB" sz="1100" dirty="0">
                <a:latin typeface="Calibri" panose="020F0502020204030204" pitchFamily="34" charset="0"/>
                <a:cs typeface="Calibri" panose="020F0502020204030204" pitchFamily="34" charset="0"/>
              </a:rPr>
              <a:t>: ocular adnexal MALT lymphoma; SA_MALT: salivary gland MALT lymphoma</a:t>
            </a:r>
            <a:r>
              <a:rPr lang="en-GB" sz="1100">
                <a:latin typeface="Calibri" panose="020F0502020204030204" pitchFamily="34" charset="0"/>
                <a:cs typeface="Calibri" panose="020F0502020204030204" pitchFamily="34" charset="0"/>
              </a:rPr>
              <a:t>; </a:t>
            </a:r>
            <a:r>
              <a:rPr lang="en-GB" sz="1100" smtClean="0">
                <a:latin typeface="Calibri" panose="020F0502020204030204" pitchFamily="34" charset="0"/>
                <a:cs typeface="Calibri" panose="020F0502020204030204" pitchFamily="34" charset="0"/>
              </a:rPr>
              <a:t>GA_MALT</a:t>
            </a:r>
            <a:r>
              <a:rPr lang="en-GB" sz="1100" dirty="0">
                <a:latin typeface="Calibri" panose="020F0502020204030204" pitchFamily="34" charset="0"/>
                <a:cs typeface="Calibri" panose="020F0502020204030204" pitchFamily="34" charset="0"/>
              </a:rPr>
              <a:t>:  Gastric MALT lymphoma;  FL: follicular lymphoma;  SMZL: splenic marginal zone lymphoma;  AITL: </a:t>
            </a:r>
            <a:r>
              <a:rPr lang="en-GB" sz="1100" dirty="0" err="1">
                <a:latin typeface="Calibri" panose="020F0502020204030204" pitchFamily="34" charset="0"/>
                <a:cs typeface="Calibri" panose="020F0502020204030204" pitchFamily="34" charset="0"/>
              </a:rPr>
              <a:t>angioimmunoblastic</a:t>
            </a:r>
            <a:r>
              <a:rPr lang="en-GB" sz="1100" dirty="0">
                <a:latin typeface="Calibri" panose="020F0502020204030204" pitchFamily="34" charset="0"/>
                <a:cs typeface="Calibri" panose="020F0502020204030204" pitchFamily="34" charset="0"/>
              </a:rPr>
              <a:t> T-cell lymphoma;  MEITL:  monomorphic </a:t>
            </a:r>
            <a:r>
              <a:rPr lang="en-GB" sz="1100" dirty="0" err="1">
                <a:latin typeface="Calibri" panose="020F0502020204030204" pitchFamily="34" charset="0"/>
                <a:cs typeface="Calibri" panose="020F0502020204030204" pitchFamily="34" charset="0"/>
              </a:rPr>
              <a:t>epitheliotropic</a:t>
            </a:r>
            <a:r>
              <a:rPr lang="en-GB" sz="1100" dirty="0">
                <a:latin typeface="Calibri" panose="020F0502020204030204" pitchFamily="34" charset="0"/>
                <a:cs typeface="Calibri" panose="020F0502020204030204" pitchFamily="34" charset="0"/>
              </a:rPr>
              <a:t> intestinal T-cell lymphomas.</a:t>
            </a:r>
          </a:p>
        </p:txBody>
      </p:sp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0978" y="1499538"/>
            <a:ext cx="6506297" cy="50384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527928217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2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Default Design">
      <a:majorFont>
        <a:latin typeface="Times New Roman"/>
        <a:ea typeface=""/>
        <a:cs typeface=""/>
      </a:majorFont>
      <a:minorFont>
        <a:latin typeface="Times New Roman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228</TotalTime>
  <Words>85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宋体</vt:lpstr>
      <vt:lpstr>Calibri</vt:lpstr>
      <vt:lpstr>Times New Roman</vt:lpstr>
      <vt:lpstr>Default Design</vt:lpstr>
      <vt:lpstr>PowerPoint Presentation</vt:lpstr>
    </vt:vector>
  </TitlesOfParts>
  <Company>Cambridg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ng Du</dc:creator>
  <cp:lastModifiedBy>Ming Du</cp:lastModifiedBy>
  <cp:revision>574</cp:revision>
  <dcterms:created xsi:type="dcterms:W3CDTF">2009-09-20T11:37:28Z</dcterms:created>
  <dcterms:modified xsi:type="dcterms:W3CDTF">2021-05-05T13:41:28Z</dcterms:modified>
</cp:coreProperties>
</file>